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1" r:id="rId4"/>
    <p:sldId id="262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3" autoAdjust="0"/>
    <p:restoredTop sz="94660"/>
  </p:normalViewPr>
  <p:slideViewPr>
    <p:cSldViewPr snapToGrid="0">
      <p:cViewPr varScale="1">
        <p:scale>
          <a:sx n="63" d="100"/>
          <a:sy n="63" d="100"/>
        </p:scale>
        <p:origin x="67" y="8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6AC326-2E74-4AEF-8734-7986DC5689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11B451-6A38-46AF-AD19-01C8A3F614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11B7B7-7847-4B87-8D00-551CF0F17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7EC1A4-407F-41C9-8A83-6F84A69AE4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C0C55C-3EDD-4557-821B-78CA666E9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493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226ED5-4D79-4817-9206-7637F9EC5B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2CD741-E05F-4E56-8783-5B5D8E5205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079CC2-F74C-408C-9A77-2291368BB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A39A4D-A177-4D0D-86F6-41E4125E6C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7983FC-2F96-4459-976A-109CF5A987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0531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030A66-4AD2-4089-B6F6-5964A514597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8E66F6-FC6C-443A-A867-F253DE4C79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E68C31-E131-453C-A3F7-567EC2858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9A41FC-0DB8-4F16-BA7F-778513F73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BF2D8D-483B-4289-99BD-A3630BC4D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797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9E027D-7F48-4597-9860-1936CB9147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C3A372-FB4D-4095-87E4-594C744B9F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60458C-22BD-464F-95CD-51F884115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3B4E68-7F29-4723-BE0F-32F52005D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0D991E-4AFE-45AA-91B4-CD955C0B2B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892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0749FE-1D49-4951-9158-2735A85F2B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FD206A-F2F3-4746-876B-9AD424B7CF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DF1392-477C-42B0-9DC6-CB1E43DE5D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932520-DACB-4DD0-B22D-F938A23C8F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188827-3D83-442E-B0E7-EB9539EEE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572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CFE178-8049-49FD-B05F-DA174C0B0C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F41A6D-7DD9-47CB-ABFA-7E8E415060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F02F44-A6DF-41C4-819A-E60479CDF6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22F659-C6D3-4827-8758-F7CEBBFA5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A5412B-A7C7-4E8D-A4D1-1352BEC8A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E86CFE-5C08-4B3F-A8EE-082FE0E6A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40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042AD0-BAD8-426C-BA11-C721ECFE4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24FE04-91C8-4C3F-8388-625E549F5C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BF9313-B686-4AD9-ABD1-43EE0FF0A6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996B5F1-AFEB-420E-AC3A-203854D4FAA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EAEA25-48D2-4B3E-AEC0-07C0C73A03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11CCF04-B237-475C-ADBF-F202309AB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29D19A-1B47-42E2-8C39-08878BBDDE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FD438B-F2C8-45C7-B458-2AF8BC42B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5465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CA9C62-D205-40EC-A5D5-17D7DBF927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1EA37A5-7F2E-41F1-A2B2-6D82F00A5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2389BD-F4F2-4903-9186-8C7EE00D7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78EB57-4F03-4407-A4AE-5AEEF4C430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6072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5C50507-821D-46F1-866A-CE503DEB5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D81CD0-7CD7-4B8C-8136-F272B69A3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D09B58-8ACD-45D2-833C-B766659709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941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74C751-7031-44E0-A218-EF4C7FBE45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DF77A9-161F-4B3E-B7D4-265428CA63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A49E76-6299-4485-A504-4A6D2047CF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F513D7-30F6-4B62-9528-0D59B2D42F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CA4806-CB17-4075-BBA1-DFD338ED8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F568CA-231A-4687-97A1-F7DE5A938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819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21DD0D-AC43-4BCF-980C-5D7A76B55D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12882D-525B-472C-8CB5-BB7C74C670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F66BA2B-C244-4ADA-AD3E-B676820F56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B8068D-B1F2-4DBA-BA83-799ECF100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BA1BAB-8304-48F2-B501-73AA5127FA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A07A42-7CD3-480C-B8B5-9A86285B5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718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6D8530F-D691-4726-ADE8-998F09D61B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080E50-7153-40F6-A747-7A1413475F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52A708-63CA-4585-AE58-4C04B74964A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EB77AF-A38F-4757-AEC8-1921F3D06CF8}" type="datetimeFigureOut">
              <a:rPr lang="en-US" smtClean="0"/>
              <a:t>3/1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22ED16-C61E-4CC8-8671-A0048FA737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F5674B-E1F9-444B-A783-E10642A584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6B935F-1DCF-4445-9C0F-C57E8C5459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0280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7" Type="http://schemas.openxmlformats.org/officeDocument/2006/relationships/image" Target="../media/image10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7" Type="http://schemas.openxmlformats.org/officeDocument/2006/relationships/image" Target="../media/image16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"/><Relationship Id="rId5" Type="http://schemas.openxmlformats.org/officeDocument/2006/relationships/image" Target="../media/image14.tif"/><Relationship Id="rId4" Type="http://schemas.openxmlformats.org/officeDocument/2006/relationships/image" Target="../media/image13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tif"/><Relationship Id="rId4" Type="http://schemas.openxmlformats.org/officeDocument/2006/relationships/image" Target="../media/image1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building, indoor, wall, white&#10;&#10;Description automatically generated">
            <a:extLst>
              <a:ext uri="{FF2B5EF4-FFF2-40B4-BE49-F238E27FC236}">
                <a16:creationId xmlns:a16="http://schemas.microsoft.com/office/drawing/2014/main" id="{F4029A2E-4668-4C7B-BCE6-D99E8AB02E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6835" y="2322679"/>
            <a:ext cx="2504150" cy="1951904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8D3DB5A6-DB5D-4AA5-82D6-85D3291896DF}"/>
              </a:ext>
            </a:extLst>
          </p:cNvPr>
          <p:cNvSpPr/>
          <p:nvPr/>
        </p:nvSpPr>
        <p:spPr>
          <a:xfrm>
            <a:off x="2229754" y="3608832"/>
            <a:ext cx="768153" cy="1981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pic>
        <p:nvPicPr>
          <p:cNvPr id="7" name="Picture 6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AB02609E-513E-498C-902D-017EDB0092A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3904" y="2355512"/>
            <a:ext cx="2504150" cy="1951904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14DED605-C621-4503-A224-88E921EC9CDC}"/>
              </a:ext>
            </a:extLst>
          </p:cNvPr>
          <p:cNvSpPr/>
          <p:nvPr/>
        </p:nvSpPr>
        <p:spPr>
          <a:xfrm>
            <a:off x="5293380" y="3332159"/>
            <a:ext cx="768153" cy="2087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C41B6B6-7BF3-4FD4-B531-CB88FBC28B51}"/>
              </a:ext>
            </a:extLst>
          </p:cNvPr>
          <p:cNvSpPr/>
          <p:nvPr/>
        </p:nvSpPr>
        <p:spPr>
          <a:xfrm>
            <a:off x="5311668" y="3606479"/>
            <a:ext cx="768153" cy="2087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A7EB7B4-3945-48F4-BC78-05D634AE409F}"/>
              </a:ext>
            </a:extLst>
          </p:cNvPr>
          <p:cNvSpPr txBox="1"/>
          <p:nvPr/>
        </p:nvSpPr>
        <p:spPr>
          <a:xfrm>
            <a:off x="1389888" y="914400"/>
            <a:ext cx="2260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iginal gel of figure 1</a:t>
            </a:r>
          </a:p>
        </p:txBody>
      </p:sp>
    </p:spTree>
    <p:extLst>
      <p:ext uri="{BB962C8B-B14F-4D97-AF65-F5344CB8AC3E}">
        <p14:creationId xmlns:p14="http://schemas.microsoft.com/office/powerpoint/2010/main" val="40324846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black and white photo of a building&#10;&#10;Description automatically generated">
            <a:extLst>
              <a:ext uri="{FF2B5EF4-FFF2-40B4-BE49-F238E27FC236}">
                <a16:creationId xmlns:a16="http://schemas.microsoft.com/office/drawing/2014/main" id="{FAE04CB0-FDBE-4B51-B77A-AB01721EE9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9068" y="2179320"/>
            <a:ext cx="3396550" cy="2380488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15FD404A-61C5-407E-9109-9C9367403287}"/>
              </a:ext>
            </a:extLst>
          </p:cNvPr>
          <p:cNvSpPr/>
          <p:nvPr/>
        </p:nvSpPr>
        <p:spPr>
          <a:xfrm>
            <a:off x="3609871" y="3864692"/>
            <a:ext cx="768153" cy="2087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pic>
        <p:nvPicPr>
          <p:cNvPr id="9" name="Picture 8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CB2CE81B-C6A9-41A9-9AF3-2C12D8F793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2071" y="2340864"/>
            <a:ext cx="2843695" cy="2218944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609FBA62-0D0A-4A6D-92DF-13A6BB446BEA}"/>
              </a:ext>
            </a:extLst>
          </p:cNvPr>
          <p:cNvSpPr/>
          <p:nvPr/>
        </p:nvSpPr>
        <p:spPr>
          <a:xfrm>
            <a:off x="7194319" y="3498932"/>
            <a:ext cx="768153" cy="20872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7F04369-4439-4E61-BA66-287F71A05568}"/>
              </a:ext>
            </a:extLst>
          </p:cNvPr>
          <p:cNvSpPr txBox="1"/>
          <p:nvPr/>
        </p:nvSpPr>
        <p:spPr>
          <a:xfrm>
            <a:off x="1792224" y="987552"/>
            <a:ext cx="2260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iginal gel of figure 2</a:t>
            </a:r>
          </a:p>
        </p:txBody>
      </p:sp>
    </p:spTree>
    <p:extLst>
      <p:ext uri="{BB962C8B-B14F-4D97-AF65-F5344CB8AC3E}">
        <p14:creationId xmlns:p14="http://schemas.microsoft.com/office/powerpoint/2010/main" val="13487582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203B6FC-F096-47B0-81B1-D506D77378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862" y="1260179"/>
            <a:ext cx="2514938" cy="1962414"/>
          </a:xfrm>
          <a:prstGeom prst="rect">
            <a:avLst/>
          </a:prstGeom>
        </p:spPr>
      </p:pic>
      <p:pic>
        <p:nvPicPr>
          <p:cNvPr id="5" name="Picture 4" descr="A picture containing wall, water&#10;&#10;Description automatically generated">
            <a:extLst>
              <a:ext uri="{FF2B5EF4-FFF2-40B4-BE49-F238E27FC236}">
                <a16:creationId xmlns:a16="http://schemas.microsoft.com/office/drawing/2014/main" id="{6CD5291D-9C39-4A2A-8C71-02EF5F24FD0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7947" y="1260179"/>
            <a:ext cx="2517633" cy="1962414"/>
          </a:xfrm>
          <a:prstGeom prst="rect">
            <a:avLst/>
          </a:prstGeom>
        </p:spPr>
      </p:pic>
      <p:pic>
        <p:nvPicPr>
          <p:cNvPr id="7" name="Picture 6" descr="A picture containing bottle, indoor, wine, water&#10;&#10;Description automatically generated">
            <a:extLst>
              <a:ext uri="{FF2B5EF4-FFF2-40B4-BE49-F238E27FC236}">
                <a16:creationId xmlns:a16="http://schemas.microsoft.com/office/drawing/2014/main" id="{441D943D-083A-4082-A33E-10A64D80CF9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0209" y="1260178"/>
            <a:ext cx="2514937" cy="196241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EA1C7DA-C5EE-4DDF-AE0F-D242190CA051}"/>
              </a:ext>
            </a:extLst>
          </p:cNvPr>
          <p:cNvSpPr txBox="1"/>
          <p:nvPr/>
        </p:nvSpPr>
        <p:spPr>
          <a:xfrm>
            <a:off x="999067" y="524933"/>
            <a:ext cx="2260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iginal gel of figure 3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CE195B22-1B5C-4D88-9B1A-13F1D28D025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861" y="4263296"/>
            <a:ext cx="2514937" cy="196241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8A1AF78-18CE-4E6A-BE0F-206A679383D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30642" y="4263295"/>
            <a:ext cx="2514938" cy="1962414"/>
          </a:xfrm>
          <a:prstGeom prst="rect">
            <a:avLst/>
          </a:prstGeom>
        </p:spPr>
      </p:pic>
      <p:pic>
        <p:nvPicPr>
          <p:cNvPr id="14" name="Picture 13" descr="A bottle of wine&#10;&#10;Description automatically generated">
            <a:extLst>
              <a:ext uri="{FF2B5EF4-FFF2-40B4-BE49-F238E27FC236}">
                <a16:creationId xmlns:a16="http://schemas.microsoft.com/office/drawing/2014/main" id="{1A498196-CC08-40A2-96CC-B22B0E00AA5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0209" y="4263295"/>
            <a:ext cx="2514936" cy="1962412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F7F2DDBA-BAFE-41D9-BA5B-3DEC4E50294A}"/>
              </a:ext>
            </a:extLst>
          </p:cNvPr>
          <p:cNvSpPr/>
          <p:nvPr/>
        </p:nvSpPr>
        <p:spPr>
          <a:xfrm>
            <a:off x="999067" y="2645664"/>
            <a:ext cx="2036741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538243C-F5FF-48EA-9320-0B3F8687F7A9}"/>
              </a:ext>
            </a:extLst>
          </p:cNvPr>
          <p:cNvSpPr/>
          <p:nvPr/>
        </p:nvSpPr>
        <p:spPr>
          <a:xfrm>
            <a:off x="4620767" y="2241384"/>
            <a:ext cx="1865377" cy="24578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76416FE-BA5B-45F4-9445-81EF6C62265B}"/>
              </a:ext>
            </a:extLst>
          </p:cNvPr>
          <p:cNvSpPr/>
          <p:nvPr/>
        </p:nvSpPr>
        <p:spPr>
          <a:xfrm>
            <a:off x="8851392" y="1929811"/>
            <a:ext cx="1828800" cy="1794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4C59036-EC51-4BE1-BB0C-B9D1B6DCF641}"/>
              </a:ext>
            </a:extLst>
          </p:cNvPr>
          <p:cNvSpPr/>
          <p:nvPr/>
        </p:nvSpPr>
        <p:spPr>
          <a:xfrm>
            <a:off x="1146048" y="5683165"/>
            <a:ext cx="1889760" cy="16899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567F523-E1D8-4907-A8C6-D334AA76A4A1}"/>
              </a:ext>
            </a:extLst>
          </p:cNvPr>
          <p:cNvSpPr/>
          <p:nvPr/>
        </p:nvSpPr>
        <p:spPr>
          <a:xfrm>
            <a:off x="4588764" y="5244501"/>
            <a:ext cx="1897380" cy="2297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B6BB492-2342-44E0-A858-E5C339D96489}"/>
              </a:ext>
            </a:extLst>
          </p:cNvPr>
          <p:cNvSpPr/>
          <p:nvPr/>
        </p:nvSpPr>
        <p:spPr>
          <a:xfrm>
            <a:off x="8807196" y="4976277"/>
            <a:ext cx="1872996" cy="2682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98412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B205633-0FDB-4C75-B008-97CBD054B5B5}"/>
              </a:ext>
            </a:extLst>
          </p:cNvPr>
          <p:cNvSpPr txBox="1"/>
          <p:nvPr/>
        </p:nvSpPr>
        <p:spPr>
          <a:xfrm>
            <a:off x="1402080" y="292608"/>
            <a:ext cx="2260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iginal gel of figure 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96875B5-9D1E-4D28-9243-E13AF2C5E4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456" y="1085087"/>
            <a:ext cx="2752344" cy="2145363"/>
          </a:xfrm>
          <a:prstGeom prst="rect">
            <a:avLst/>
          </a:prstGeom>
        </p:spPr>
      </p:pic>
      <p:pic>
        <p:nvPicPr>
          <p:cNvPr id="6" name="Picture 5" descr="A picture containing sky&#10;&#10;Description automatically generated">
            <a:extLst>
              <a:ext uri="{FF2B5EF4-FFF2-40B4-BE49-F238E27FC236}">
                <a16:creationId xmlns:a16="http://schemas.microsoft.com/office/drawing/2014/main" id="{B272E3B0-D826-4E93-80A1-B55ED8BF008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6656" y="1085087"/>
            <a:ext cx="2749396" cy="2145362"/>
          </a:xfrm>
          <a:prstGeom prst="rect">
            <a:avLst/>
          </a:prstGeom>
        </p:spPr>
      </p:pic>
      <p:pic>
        <p:nvPicPr>
          <p:cNvPr id="8" name="Picture 7" descr="A picture containing bottle, indoor, object, water&#10;&#10;Description automatically generated">
            <a:extLst>
              <a:ext uri="{FF2B5EF4-FFF2-40B4-BE49-F238E27FC236}">
                <a16:creationId xmlns:a16="http://schemas.microsoft.com/office/drawing/2014/main" id="{411A7025-527F-40EC-B27B-A3483FD4517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9907" y="1085086"/>
            <a:ext cx="2749395" cy="2145361"/>
          </a:xfrm>
          <a:prstGeom prst="rect">
            <a:avLst/>
          </a:prstGeom>
        </p:spPr>
      </p:pic>
      <p:pic>
        <p:nvPicPr>
          <p:cNvPr id="10" name="Picture 9" descr="A picture containing building&#10;&#10;Description automatically generated">
            <a:extLst>
              <a:ext uri="{FF2B5EF4-FFF2-40B4-BE49-F238E27FC236}">
                <a16:creationId xmlns:a16="http://schemas.microsoft.com/office/drawing/2014/main" id="{07123DCE-04AF-458C-B6CB-94FF91F458F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455" y="3653597"/>
            <a:ext cx="2716017" cy="2119316"/>
          </a:xfrm>
          <a:prstGeom prst="rect">
            <a:avLst/>
          </a:prstGeom>
        </p:spPr>
      </p:pic>
      <p:pic>
        <p:nvPicPr>
          <p:cNvPr id="12" name="Picture 11" descr="A picture containing sky&#10;&#10;Description automatically generated">
            <a:extLst>
              <a:ext uri="{FF2B5EF4-FFF2-40B4-BE49-F238E27FC236}">
                <a16:creationId xmlns:a16="http://schemas.microsoft.com/office/drawing/2014/main" id="{41FD6A96-8B1A-4D67-91B0-32678AEEB67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6269" y="3652320"/>
            <a:ext cx="3099037" cy="2274347"/>
          </a:xfrm>
          <a:prstGeom prst="rect">
            <a:avLst/>
          </a:prstGeom>
        </p:spPr>
      </p:pic>
      <p:pic>
        <p:nvPicPr>
          <p:cNvPr id="14" name="Picture 13" descr="A close up of a bottle&#10;&#10;Description automatically generated">
            <a:extLst>
              <a:ext uri="{FF2B5EF4-FFF2-40B4-BE49-F238E27FC236}">
                <a16:creationId xmlns:a16="http://schemas.microsoft.com/office/drawing/2014/main" id="{DEF7526D-F6FA-4BAC-8969-6E0A06EA629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9906" y="4068706"/>
            <a:ext cx="2749395" cy="2145361"/>
          </a:xfrm>
          <a:prstGeom prst="rect">
            <a:avLst/>
          </a:prstGeom>
        </p:spPr>
      </p:pic>
      <p:sp>
        <p:nvSpPr>
          <p:cNvPr id="15" name="Rectangle 14">
            <a:extLst>
              <a:ext uri="{FF2B5EF4-FFF2-40B4-BE49-F238E27FC236}">
                <a16:creationId xmlns:a16="http://schemas.microsoft.com/office/drawing/2014/main" id="{062631F8-5839-42BA-8DF0-E9A3E446495B}"/>
              </a:ext>
            </a:extLst>
          </p:cNvPr>
          <p:cNvSpPr/>
          <p:nvPr/>
        </p:nvSpPr>
        <p:spPr>
          <a:xfrm>
            <a:off x="1072698" y="2706624"/>
            <a:ext cx="2036262" cy="1828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84BBCD59-63CE-4551-84DB-8D6DC4DC2301}"/>
              </a:ext>
            </a:extLst>
          </p:cNvPr>
          <p:cNvSpPr/>
          <p:nvPr/>
        </p:nvSpPr>
        <p:spPr>
          <a:xfrm>
            <a:off x="4736592" y="2157766"/>
            <a:ext cx="2103120" cy="24405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697F6FC1-8CD1-40BD-9DB0-636A9A75F4AA}"/>
              </a:ext>
            </a:extLst>
          </p:cNvPr>
          <p:cNvSpPr/>
          <p:nvPr/>
        </p:nvSpPr>
        <p:spPr>
          <a:xfrm>
            <a:off x="8872728" y="1922374"/>
            <a:ext cx="1990344" cy="2353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E739C07-3AE3-468D-A037-12AD9BA05B30}"/>
              </a:ext>
            </a:extLst>
          </p:cNvPr>
          <p:cNvSpPr/>
          <p:nvPr/>
        </p:nvSpPr>
        <p:spPr>
          <a:xfrm rot="21350888">
            <a:off x="1213316" y="5135153"/>
            <a:ext cx="1974532" cy="18165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906FEBB1-80D4-4F87-8A65-FC691538233F}"/>
              </a:ext>
            </a:extLst>
          </p:cNvPr>
          <p:cNvSpPr/>
          <p:nvPr/>
        </p:nvSpPr>
        <p:spPr>
          <a:xfrm>
            <a:off x="4893564" y="4836586"/>
            <a:ext cx="2305912" cy="32063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E287181-3068-445E-AED4-B8A6C81563E5}"/>
              </a:ext>
            </a:extLst>
          </p:cNvPr>
          <p:cNvSpPr/>
          <p:nvPr/>
        </p:nvSpPr>
        <p:spPr>
          <a:xfrm>
            <a:off x="8872729" y="4921179"/>
            <a:ext cx="1990343" cy="23603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347139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30494AE-9C33-4A4B-89B1-15DFF79FB7D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509" y="727005"/>
            <a:ext cx="3612898" cy="2816137"/>
          </a:xfrm>
          <a:prstGeom prst="rect">
            <a:avLst/>
          </a:prstGeom>
        </p:spPr>
      </p:pic>
      <p:pic>
        <p:nvPicPr>
          <p:cNvPr id="5" name="Picture 4" descr="A picture containing appliance&#10;&#10;Description automatically generated">
            <a:extLst>
              <a:ext uri="{FF2B5EF4-FFF2-40B4-BE49-F238E27FC236}">
                <a16:creationId xmlns:a16="http://schemas.microsoft.com/office/drawing/2014/main" id="{7BCBE687-30E3-4FA6-BEA8-087A80740AE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2001" y="889883"/>
            <a:ext cx="3072846" cy="2395184"/>
          </a:xfrm>
          <a:prstGeom prst="rect">
            <a:avLst/>
          </a:prstGeom>
        </p:spPr>
      </p:pic>
      <p:pic>
        <p:nvPicPr>
          <p:cNvPr id="7" name="Picture 6" descr="A picture containing wall, furniture, sky&#10;&#10;Description automatically generated">
            <a:extLst>
              <a:ext uri="{FF2B5EF4-FFF2-40B4-BE49-F238E27FC236}">
                <a16:creationId xmlns:a16="http://schemas.microsoft.com/office/drawing/2014/main" id="{347C1E4A-50A1-4AF9-B4C7-68EFA93F9AA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8432" y="3770468"/>
            <a:ext cx="3352799" cy="261339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F757787-99B9-4286-9E82-F0281550925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9906" y="3578351"/>
            <a:ext cx="3352797" cy="261339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3F51600-86A1-454F-9775-B05145DAB197}"/>
              </a:ext>
            </a:extLst>
          </p:cNvPr>
          <p:cNvSpPr txBox="1"/>
          <p:nvPr/>
        </p:nvSpPr>
        <p:spPr>
          <a:xfrm>
            <a:off x="1255776" y="231648"/>
            <a:ext cx="2260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iginal gel of figure 7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A27B1E4-CA94-47CA-B9DC-F30A963FF990}"/>
              </a:ext>
            </a:extLst>
          </p:cNvPr>
          <p:cNvSpPr/>
          <p:nvPr/>
        </p:nvSpPr>
        <p:spPr>
          <a:xfrm>
            <a:off x="2503932" y="1982673"/>
            <a:ext cx="1872996" cy="27284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0BB0561-F124-410E-8149-407D5329F899}"/>
              </a:ext>
            </a:extLst>
          </p:cNvPr>
          <p:cNvSpPr/>
          <p:nvPr/>
        </p:nvSpPr>
        <p:spPr>
          <a:xfrm>
            <a:off x="8307324" y="1536192"/>
            <a:ext cx="1507236" cy="2926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0C630FF-8489-4235-99DD-4B57C2FB8D0A}"/>
              </a:ext>
            </a:extLst>
          </p:cNvPr>
          <p:cNvSpPr/>
          <p:nvPr/>
        </p:nvSpPr>
        <p:spPr>
          <a:xfrm>
            <a:off x="2590462" y="5010111"/>
            <a:ext cx="1627970" cy="26902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1E8A7BB-0966-4C5D-B3DA-177CB0AC5BDC}"/>
              </a:ext>
            </a:extLst>
          </p:cNvPr>
          <p:cNvSpPr/>
          <p:nvPr/>
        </p:nvSpPr>
        <p:spPr>
          <a:xfrm>
            <a:off x="8197596" y="5089543"/>
            <a:ext cx="1726692" cy="22007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93607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</TotalTime>
  <Words>25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ng, Xiaoli</dc:creator>
  <cp:lastModifiedBy>Tang, Xiaoli</cp:lastModifiedBy>
  <cp:revision>16</cp:revision>
  <dcterms:created xsi:type="dcterms:W3CDTF">2020-03-11T14:25:42Z</dcterms:created>
  <dcterms:modified xsi:type="dcterms:W3CDTF">2020-03-11T16:41:58Z</dcterms:modified>
</cp:coreProperties>
</file>